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 showGuides="1">
      <p:cViewPr varScale="1">
        <p:scale>
          <a:sx n="108" d="100"/>
          <a:sy n="108" d="100"/>
        </p:scale>
        <p:origin x="516" y="15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E82608-1448-48A4-B6E2-DE91E69E4C0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769D143-4A56-4258-B29B-F02CF0C98D4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5B27BA-5473-429E-81BC-CD7B6F725E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0B7D7C-989E-41BA-A7B5-1548496D3D38}" type="datetimeFigureOut">
              <a:rPr lang="en-US" smtClean="0"/>
              <a:t>1/3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EB03B6-8D84-4F26-A7C5-B2E4F01DD1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A4D6DB-0C98-4F80-AC14-7AB37EDAC1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44F03A-FD3E-46D0-9BBB-70CDC876B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65801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FA536E-5327-4C70-B3AA-27C249C871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64D6A3D-036F-4797-B50C-3356828846A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DDA8FB-7BDA-4AA3-86B8-A3797595D0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0B7D7C-989E-41BA-A7B5-1548496D3D38}" type="datetimeFigureOut">
              <a:rPr lang="en-US" smtClean="0"/>
              <a:t>1/3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10365A-8D23-4E95-8BBC-4E56BB96D4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6CED18-8C24-4A66-92AD-052E988BCE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44F03A-FD3E-46D0-9BBB-70CDC876B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8941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161BAB6-1D7E-433B-84CC-DC8B4595562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DB1EC9F-053F-4BE9-A562-23BF19EEB5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17D705-A51B-46BF-BF88-B9012D8D4C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0B7D7C-989E-41BA-A7B5-1548496D3D38}" type="datetimeFigureOut">
              <a:rPr lang="en-US" smtClean="0"/>
              <a:t>1/3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CF4FF9-E824-4FA8-BCD3-D1A0648004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B9379D-695A-4AB0-89E9-CA77FBBA07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44F03A-FD3E-46D0-9BBB-70CDC876B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3124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359708-482B-445B-96A8-F8E1045209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E33656F-011D-45DC-9450-A0C9217E440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9C92CD-6458-4321-9A83-DE6D5A2C3A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0B7D7C-989E-41BA-A7B5-1548496D3D38}" type="datetimeFigureOut">
              <a:rPr lang="en-US" smtClean="0"/>
              <a:t>1/3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8192CA-1E3B-41B0-8F91-55EFD14CB1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4B7AD1-A67A-4176-AED9-F53D70B4AA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44F03A-FD3E-46D0-9BBB-70CDC876B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98904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C0DA9A-A17B-4415-9C01-92927428BE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A7CA933-A6B2-41B0-9E0A-472E322EF9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4832B2-0E93-4778-8A84-3CD33D9B49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0B7D7C-989E-41BA-A7B5-1548496D3D38}" type="datetimeFigureOut">
              <a:rPr lang="en-US" smtClean="0"/>
              <a:t>1/3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502C41-1DF0-47C4-AD61-614F05C9C6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7B0A9B-9BFB-4A27-95F5-B7754D50A0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44F03A-FD3E-46D0-9BBB-70CDC876B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7487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2376FF-D383-41B6-BB38-3C9120F747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55C0EDB-514A-4CF1-AA1D-352CF563D81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918F78F-7430-402F-A974-504E4CEFEC6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C9B929B-ED56-464D-AA92-6B4600D20B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0B7D7C-989E-41BA-A7B5-1548496D3D38}" type="datetimeFigureOut">
              <a:rPr lang="en-US" smtClean="0"/>
              <a:t>1/3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E054642-235D-48DB-8DB2-73714D1F0B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D57E6B-9581-4810-8522-A5EB40CF9D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44F03A-FD3E-46D0-9BBB-70CDC876B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07048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9C69DB-54F8-4206-8F4F-45DEE6B0F4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ADCC6C1-B8BE-43F0-BA54-47EEF0E53F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923F650-9837-4D8A-8D47-2D4FC655F2D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8E98F65-EC11-4BDD-9923-8E5F5F0BF2D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1AB9F31-3680-4146-A3E3-17918554B46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3424524-1ADB-46F3-81D4-215937A050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0B7D7C-989E-41BA-A7B5-1548496D3D38}" type="datetimeFigureOut">
              <a:rPr lang="en-US" smtClean="0"/>
              <a:t>1/31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A3187D9-5415-47ED-8EA2-6E3626B2A8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0C182AF-3BDE-4D6F-920E-CBC640A82E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44F03A-FD3E-46D0-9BBB-70CDC876B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40673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00F64F-8721-4D88-BC04-16B462C637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BC2A837-D12D-4574-9FB9-32B2715AB1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0B7D7C-989E-41BA-A7B5-1548496D3D38}" type="datetimeFigureOut">
              <a:rPr lang="en-US" smtClean="0"/>
              <a:t>1/31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ED13136-4FD7-443C-A6D2-7DE8A924B6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5ABD184-A30A-4ACD-8E54-B503DE02FF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44F03A-FD3E-46D0-9BBB-70CDC876B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33299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5C44C9A-2BC6-4CA7-BC72-5EAE403C26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0B7D7C-989E-41BA-A7B5-1548496D3D38}" type="datetimeFigureOut">
              <a:rPr lang="en-US" smtClean="0"/>
              <a:t>1/31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887FDEB-2955-4BEF-AA98-8C8041375D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C4F574D-A73C-4546-B305-0414ADB4F1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44F03A-FD3E-46D0-9BBB-70CDC876B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45615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2BFC47-95D5-4AD0-8EC9-02B76F4B9A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40E75C1-770D-43E0-921A-BB39B9E3A68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F1E2374-CC22-4C6A-8F2C-B408D7A4921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8B337E8-A839-4DDC-A4EE-6463D46672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0B7D7C-989E-41BA-A7B5-1548496D3D38}" type="datetimeFigureOut">
              <a:rPr lang="en-US" smtClean="0"/>
              <a:t>1/3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BDBC9E0-A340-4696-8C8E-1640D937A0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9258568-7414-42E8-A5DE-13256F038B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44F03A-FD3E-46D0-9BBB-70CDC876B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79677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4B2554-2A9B-44B9-95E8-869C19898F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954E60A-FE69-4210-BBD8-8D34FD7D02A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15CDD22-B4EE-4729-94C1-756D5B8CD6C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E1D1579-CA24-4BD8-A39D-EF2725312C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0B7D7C-989E-41BA-A7B5-1548496D3D38}" type="datetimeFigureOut">
              <a:rPr lang="en-US" smtClean="0"/>
              <a:t>1/3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04569EA-F8C0-4FEC-9516-280462DF76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07D2627-46C7-49CC-A615-8FBA58C89B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44F03A-FD3E-46D0-9BBB-70CDC876B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35958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7562765-4447-441C-8A0D-258C191D36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144A54B-1754-437D-8178-A3D1BD23F7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023182-891D-4D77-8FCE-19E53DF6E64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0B7D7C-989E-41BA-A7B5-1548496D3D38}" type="datetimeFigureOut">
              <a:rPr lang="en-US" smtClean="0"/>
              <a:t>1/3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AB8D87-298B-4FD5-8802-DC64D5BDBF4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315313-A479-4306-B720-91E540CE34F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44F03A-FD3E-46D0-9BBB-70CDC876B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30529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02BAE2E-E4F8-4169-80AB-D61276DD5475}"/>
              </a:ext>
            </a:extLst>
          </p:cNvPr>
          <p:cNvSpPr txBox="1">
            <a:spLocks/>
          </p:cNvSpPr>
          <p:nvPr/>
        </p:nvSpPr>
        <p:spPr>
          <a:xfrm>
            <a:off x="-50975" y="31363"/>
            <a:ext cx="2037430" cy="1325563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de-DE"/>
              <a:t>SFig. 1</a:t>
            </a:r>
            <a:endParaRPr lang="de-DE" dirty="0"/>
          </a:p>
        </p:txBody>
      </p:sp>
      <p:sp>
        <p:nvSpPr>
          <p:cNvPr id="9" name="Textfeld 10">
            <a:extLst>
              <a:ext uri="{FF2B5EF4-FFF2-40B4-BE49-F238E27FC236}">
                <a16:creationId xmlns:a16="http://schemas.microsoft.com/office/drawing/2014/main" id="{58D7A718-7715-4ADA-A294-FDD88B87EE68}"/>
              </a:ext>
            </a:extLst>
          </p:cNvPr>
          <p:cNvSpPr txBox="1"/>
          <p:nvPr/>
        </p:nvSpPr>
        <p:spPr>
          <a:xfrm>
            <a:off x="-50975" y="5759146"/>
            <a:ext cx="12242976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Fig</a:t>
            </a:r>
            <a:r>
              <a:rPr lang="de-DE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1: </a:t>
            </a: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esting of Epoxiconazole and Prochloraz in selected humanized in vitro assays reflecting potential MIEs; 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B) 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No obvious effects were seen for DIO1-3, DEHAL1, NIS, TPO and MCT8 function up to the maximal tested concentration of 50µM (mean+/-SD, </a:t>
            </a:r>
            <a:r>
              <a:rPr lang="en-US" sz="16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N=2, n=2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. (</a:t>
            </a:r>
            <a:r>
              <a:rPr lang="en-US" sz="16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-D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 Functionality of the assays was tested by dose-response experiments with respective known positive control compounds. </a:t>
            </a:r>
            <a:r>
              <a:rPr lang="en-US" sz="16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Exemplary curves were normalized to 100% (solvent control) and 0% (maximal effect) activity (mean+/-SD, </a:t>
            </a:r>
            <a:r>
              <a:rPr lang="en-US" sz="1600" dirty="0">
                <a:solidFill>
                  <a:srgbClr val="FF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N=</a:t>
            </a:r>
            <a:r>
              <a:rPr lang="en-US" sz="1600">
                <a:solidFill>
                  <a:srgbClr val="FF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1, n</a:t>
            </a:r>
            <a:r>
              <a:rPr lang="en-US" sz="1600" dirty="0">
                <a:solidFill>
                  <a:srgbClr val="FF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=3</a:t>
            </a:r>
            <a:r>
              <a:rPr lang="en-US" sz="16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.</a:t>
            </a:r>
            <a:endParaRPr lang="de-DE" sz="1600" dirty="0"/>
          </a:p>
        </p:txBody>
      </p:sp>
      <p:pic>
        <p:nvPicPr>
          <p:cNvPr id="20" name="Grafik 19">
            <a:extLst>
              <a:ext uri="{FF2B5EF4-FFF2-40B4-BE49-F238E27FC236}">
                <a16:creationId xmlns:a16="http://schemas.microsoft.com/office/drawing/2014/main" id="{FE3E60E2-E039-4BBA-9883-67C05E105C3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79591" y="424463"/>
            <a:ext cx="8321761" cy="51393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919984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3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rau Dr. Marize De Lourdes Marzo Solano</dc:creator>
  <cp:lastModifiedBy>Frau Dr. Marize De Lourdes Marzo Solano</cp:lastModifiedBy>
  <cp:revision>6</cp:revision>
  <dcterms:created xsi:type="dcterms:W3CDTF">2023-11-22T08:02:17Z</dcterms:created>
  <dcterms:modified xsi:type="dcterms:W3CDTF">2024-01-31T15:14:00Z</dcterms:modified>
</cp:coreProperties>
</file>